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4.png" ContentType="image/png"/>
  <Override PartName="/ppt/media/image2.pct" ContentType="image/x-pict"/>
  <Override PartName="/ppt/media/image5.png" ContentType="image/png"/>
  <Override PartName="/ppt/media/image3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15184-206E-4BB5-A392-51CA740FF8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53944-A670-40E3-A211-636FEE9504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801FC-BEC3-4FB2-8A39-781E4A6C29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E6051-5857-4A08-97FF-98B836D84A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6AB3A-D4F7-4B3E-9C8C-4B433ABE51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A37925-14F7-4D50-89DE-E609FF9BCD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059CB-B049-4458-B7E0-15510DF3AA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11093-82B2-4D2A-99AF-21772D7030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E682E-1ACE-490D-AC86-75568FD5EE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65A97-9ECB-4E78-B0C0-40B0C4AE75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DCEB8-D5EA-433E-BA1C-8716B0DAC3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54A42E-9E87-4091-AAEA-B43666257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F65DF0-4C3F-4487-B2DA-66DA290D137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782880" y="3454560"/>
            <a:ext cx="2021040" cy="657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806760" y="3366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43400" y="31035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1208160" y="3432240"/>
            <a:ext cx="1828800" cy="59508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184760" y="3433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91000" y="3433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408400" y="34336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147760" y="3433680"/>
            <a:ext cx="282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652480" y="343368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80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604520" y="34336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919160" y="3992400"/>
            <a:ext cx="39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762120" y="3616920"/>
            <a:ext cx="72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numb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709280" y="7021440"/>
            <a:ext cx="88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B: CyclinB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097160" y="7040520"/>
            <a:ext cx="100224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B: PKA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 baseline="-25000">
                <a:solidFill>
                  <a:srgbClr val="000000"/>
                </a:solidFill>
                <a:latin typeface="Arial"/>
              </a:rPr>
              <a:t>catalyti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773720" y="7446960"/>
            <a:ext cx="697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B: Cdk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50960" y="417024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3474360" y="365688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574880" y="407340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786120" y="324972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ck (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495320" y="3249720"/>
            <a:ext cx="6044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pr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v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(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178960" y="324972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IV (3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242160" y="31431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075920" y="366696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458680" y="33764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625720" y="372420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654360" y="505296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654360" y="522288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654360" y="528948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654360" y="55562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654360" y="61088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654360" y="63896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654360" y="658188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654360" y="67406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654360" y="580248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436920" y="66549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436920" y="64990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436920" y="62974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436920" y="60292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380040" y="57038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380040" y="5457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380040" y="5256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380040" y="5092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380040" y="4948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93760" y="506412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193760" y="52340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193760" y="53006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193760" y="556740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193760" y="61214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193760" y="640404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193760" y="659592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193760" y="675648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193760" y="5816520"/>
            <a:ext cx="133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982800" y="66722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982800" y="65102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982800" y="63104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982800" y="6041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925920" y="57182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925920" y="54673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925920" y="5268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925920" y="5106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925920" y="4957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820960" y="5264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820960" y="54594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822400" y="59529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102560" y="3017880"/>
            <a:ext cx="697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B: Cdk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069080" y="7160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281480" y="71604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823920" y="73656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745160" y="7160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4924440" y="71604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535280" y="73656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570560" y="716040"/>
            <a:ext cx="547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525840" y="519120"/>
            <a:ext cx="44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SS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066200" y="43164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732560" y="48096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643200" y="121428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643200" y="137808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643200" y="144288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643200" y="170028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643200" y="191628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643200" y="219384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643200" y="246384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643200" y="264780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643200" y="280188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403800" y="27068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403800" y="2554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403800" y="23684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403800" y="2117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346920" y="1827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346920" y="16128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346920" y="1384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346920" y="12574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346920" y="10954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" descr=""/>
          <p:cNvPicPr/>
          <p:nvPr/>
        </p:nvPicPr>
        <p:blipFill>
          <a:blip r:embed="rId3"/>
          <a:stretch/>
        </p:blipFill>
        <p:spPr>
          <a:xfrm>
            <a:off x="3773520" y="911160"/>
            <a:ext cx="1379520" cy="1963800"/>
          </a:xfrm>
          <a:prstGeom prst="rect">
            <a:avLst/>
          </a:prstGeom>
          <a:ln w="0">
            <a:noFill/>
          </a:ln>
        </p:spPr>
      </p:pic>
      <p:sp>
        <p:nvSpPr>
          <p:cNvPr id="135" name=""/>
          <p:cNvSpPr/>
          <p:nvPr/>
        </p:nvSpPr>
        <p:spPr>
          <a:xfrm>
            <a:off x="3898800" y="716040"/>
            <a:ext cx="547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373040" y="141444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373040" y="147780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373040" y="173340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373040" y="194940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373040" y="222552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373040" y="249552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373040" y="267984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373040" y="2832120"/>
            <a:ext cx="1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143000" y="27338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143000" y="2581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143000" y="23893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143000" y="21319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086120" y="1839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086120" y="1622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086120" y="14130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086120" y="1285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370160" y="1230480"/>
            <a:ext cx="128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3" name="" descr=""/>
          <p:cNvPicPr/>
          <p:nvPr/>
        </p:nvPicPr>
        <p:blipFill>
          <a:blip r:embed="rId4"/>
          <a:stretch/>
        </p:blipFill>
        <p:spPr>
          <a:xfrm>
            <a:off x="1500120" y="1120680"/>
            <a:ext cx="1352520" cy="1728720"/>
          </a:xfrm>
          <a:prstGeom prst="rect">
            <a:avLst/>
          </a:prstGeom>
          <a:ln w="0">
            <a:noFill/>
          </a:ln>
        </p:spPr>
      </p:pic>
      <p:sp>
        <p:nvSpPr>
          <p:cNvPr id="154" name=""/>
          <p:cNvSpPr/>
          <p:nvPr/>
        </p:nvSpPr>
        <p:spPr>
          <a:xfrm>
            <a:off x="1746000" y="2994120"/>
            <a:ext cx="88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B: CyclinB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795400" y="14065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795400" y="15685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795400" y="1825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795400" y="20732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086120" y="11192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764000" y="9320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976400" y="93204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518840" y="95724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440080" y="9320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619360" y="93204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230200" y="95724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265480" y="950760"/>
            <a:ext cx="547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220760" y="754200"/>
            <a:ext cx="44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SS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761120" y="66672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427480" y="71604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593720" y="950760"/>
            <a:ext cx="547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" descr=""/>
          <p:cNvPicPr/>
          <p:nvPr/>
        </p:nvPicPr>
        <p:blipFill>
          <a:blip r:embed="rId5"/>
          <a:stretch/>
        </p:blipFill>
        <p:spPr>
          <a:xfrm>
            <a:off x="1327320" y="4713120"/>
            <a:ext cx="1544400" cy="2168640"/>
          </a:xfrm>
          <a:prstGeom prst="rect">
            <a:avLst/>
          </a:prstGeom>
          <a:ln w="0">
            <a:noFill/>
          </a:ln>
        </p:spPr>
      </p:pic>
      <p:pic>
        <p:nvPicPr>
          <p:cNvPr id="172" name="" descr=""/>
          <p:cNvPicPr/>
          <p:nvPr/>
        </p:nvPicPr>
        <p:blipFill>
          <a:blip r:embed="rId6"/>
          <a:stretch/>
        </p:blipFill>
        <p:spPr>
          <a:xfrm>
            <a:off x="3787920" y="4722840"/>
            <a:ext cx="1508040" cy="2155680"/>
          </a:xfrm>
          <a:prstGeom prst="rect">
            <a:avLst/>
          </a:prstGeom>
          <a:ln w="0">
            <a:noFill/>
          </a:ln>
        </p:spPr>
      </p:pic>
      <p:sp>
        <p:nvSpPr>
          <p:cNvPr id="173" name=""/>
          <p:cNvSpPr/>
          <p:nvPr/>
        </p:nvSpPr>
        <p:spPr>
          <a:xfrm>
            <a:off x="1687320" y="451332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900440" y="451332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1443600" y="4513320"/>
            <a:ext cx="27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363760" y="451332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573640" y="451332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154960" y="4513320"/>
            <a:ext cx="27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189160" y="4513320"/>
            <a:ext cx="547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144440" y="4316400"/>
            <a:ext cx="44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SS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684800" y="422928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351160" y="427824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517760" y="4513320"/>
            <a:ext cx="547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122720" y="452592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335480" y="452592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879000" y="4525920"/>
            <a:ext cx="27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4798800" y="452592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5008680" y="452592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4590000" y="4525920"/>
            <a:ext cx="27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624560" y="4525920"/>
            <a:ext cx="547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579840" y="4329000"/>
            <a:ext cx="44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SS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120200" y="424188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786560" y="429084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952800" y="4525920"/>
            <a:ext cx="547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5" name="" descr=""/>
          <p:cNvPicPr/>
          <p:nvPr/>
        </p:nvPicPr>
        <p:blipFill>
          <a:blip r:embed="rId7"/>
          <a:stretch/>
        </p:blipFill>
        <p:spPr>
          <a:xfrm>
            <a:off x="1295280" y="7250040"/>
            <a:ext cx="1571760" cy="238320"/>
          </a:xfrm>
          <a:prstGeom prst="rect">
            <a:avLst/>
          </a:prstGeom>
          <a:ln w="0">
            <a:noFill/>
          </a:ln>
        </p:spPr>
      </p:pic>
      <p:sp>
        <p:nvSpPr>
          <p:cNvPr id="196" name=""/>
          <p:cNvSpPr/>
          <p:nvPr/>
        </p:nvSpPr>
        <p:spPr>
          <a:xfrm>
            <a:off x="3130920" y="3618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214800" y="417024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763640" y="2811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027160" y="2811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1512720" y="2811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420640" y="2811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600280" y="2811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242800" y="2811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1528920" y="3014640"/>
            <a:ext cx="1309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055760" y="2836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344840" y="2836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805200" y="2836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713120" y="2836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4892400" y="2836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560840" y="2836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821040" y="3040200"/>
            <a:ext cx="1309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65564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90656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39824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35728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59380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214776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1433520" y="7047000"/>
            <a:ext cx="1360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410040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435132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384300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80204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503856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592520" y="68436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878280" y="7047000"/>
            <a:ext cx="1360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101960" y="97956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353040" y="95256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938160" y="480996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394080" y="4800600"/>
            <a:ext cx="33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823840" y="574056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5126040" y="1382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5126040" y="1544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5126040" y="18018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5126040" y="20494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972880" y="8381880"/>
            <a:ext cx="9532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1T21:45:23Z</dcterms:created>
  <dc:creator>N. I. A. I. D. N. I. H.</dc:creator>
  <dc:description/>
  <dc:language>en-US</dc:language>
  <cp:lastModifiedBy>N. I. A. I. D. N. I. H.</cp:lastModifiedBy>
  <dcterms:modified xsi:type="dcterms:W3CDTF">2008-03-11T21:48:37Z</dcterms:modified>
  <cp:revision>14</cp:revision>
  <dc:subject/>
  <dc:title>PowerPoint Presentation</dc:title>
</cp:coreProperties>
</file>